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4ED166-9171-4A98-B2A5-6633FD9112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E36FC-52CD-4771-BBA1-4D079224B7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116C4-26CD-4CB4-B185-9E37AC1C63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912157-0DF0-4D04-9142-210639BDAE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CC5E1-AED3-4A47-938F-D24C0B60DB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959B5-E659-4D6D-A215-1FB78362D8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77A90-3AAB-4E12-94ED-B3001BF4B7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38892-8DF2-4B8A-9838-5951943D74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3AF26-6055-4F22-B7E2-62C8289E8B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7B0B2-5810-4AFA-B26A-815176F353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5CC8C-4A4A-464A-AFBF-4BCA4A5BDB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AC04C-E440-404E-BB37-6685A5AC4B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D28E4B-30A3-4758-9B6A-96BD8B4A06E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0" y="0"/>
            <a:ext cx="8915400" cy="6966000"/>
            <a:chOff x="0" y="0"/>
            <a:chExt cx="8915400" cy="6966000"/>
          </a:xfrm>
        </p:grpSpPr>
        <p:pic>
          <p:nvPicPr>
            <p:cNvPr id="42" name="Picture 2" descr="G:\NFY- Images\NFY- TOTAL.tif"/>
            <p:cNvPicPr/>
            <p:nvPr/>
          </p:nvPicPr>
          <p:blipFill>
            <a:blip r:embed="rId1"/>
            <a:stretch/>
          </p:blipFill>
          <p:spPr>
            <a:xfrm>
              <a:off x="0" y="0"/>
              <a:ext cx="8915400" cy="6172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3"/>
            <p:cNvSpPr/>
            <p:nvPr/>
          </p:nvSpPr>
          <p:spPr>
            <a:xfrm>
              <a:off x="435960" y="6324480"/>
              <a:ext cx="831456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4 Fig.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istribution of 1-10 MEME identified SbNFY-A, B, &amp; C conserved motifs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.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ene clusters and p values are shown on the left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de and motif sizes at the bottom of the figure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DMR</dc:creator>
  <dc:description/>
  <dc:language>en-US</dc:language>
  <cp:lastModifiedBy>NAGARAJU</cp:lastModifiedBy>
  <dcterms:modified xsi:type="dcterms:W3CDTF">2019-08-30T08:11:36Z</dcterms:modified>
  <cp:revision>12</cp:revision>
  <dc:subject/>
  <dc:title>Slide 1</dc:title>
</cp:coreProperties>
</file>